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96" r:id="rId1"/>
  </p:sldMasterIdLst>
  <p:sldIdLst>
    <p:sldId id="260" r:id="rId2"/>
  </p:sldIdLst>
  <p:sldSz cx="7772400" cy="4572000"/>
  <p:notesSz cx="6858000" cy="9144000"/>
  <p:defaultTextStyle>
    <a:defPPr>
      <a:defRPr lang="en-US"/>
    </a:defPPr>
    <a:lvl1pPr marL="0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1pPr>
    <a:lvl2pPr marL="296236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2pPr>
    <a:lvl3pPr marL="592473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3pPr>
    <a:lvl4pPr marL="888707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4pPr>
    <a:lvl5pPr marL="1184943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5pPr>
    <a:lvl6pPr marL="1481180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6pPr>
    <a:lvl7pPr marL="1777416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7pPr>
    <a:lvl8pPr marL="2073653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8pPr>
    <a:lvl9pPr marL="2369887" algn="l" defTabSz="592473" rtl="0" eaLnBrk="1" latinLnBrk="0" hangingPunct="1">
      <a:defRPr sz="1166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2F6C"/>
    <a:srgbClr val="0071BC"/>
    <a:srgbClr val="008AD8"/>
    <a:srgbClr val="E1E1E1"/>
    <a:srgbClr val="CBCBCB"/>
    <a:srgbClr val="929292"/>
    <a:srgbClr val="515151"/>
    <a:srgbClr val="000000"/>
    <a:srgbClr val="7F1B20"/>
    <a:srgbClr val="3B4E5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084" autoAdjust="0"/>
    <p:restoredTop sz="94660"/>
  </p:normalViewPr>
  <p:slideViewPr>
    <p:cSldViewPr snapToGrid="0">
      <p:cViewPr>
        <p:scale>
          <a:sx n="190" d="100"/>
          <a:sy n="190" d="100"/>
        </p:scale>
        <p:origin x="76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71550" y="748242"/>
            <a:ext cx="5829300" cy="1591733"/>
          </a:xfrm>
        </p:spPr>
        <p:txBody>
          <a:bodyPr anchor="b"/>
          <a:lstStyle>
            <a:lvl1pPr algn="ctr">
              <a:defRPr sz="382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2401359"/>
            <a:ext cx="5829300" cy="1103841"/>
          </a:xfrm>
        </p:spPr>
        <p:txBody>
          <a:bodyPr/>
          <a:lstStyle>
            <a:lvl1pPr marL="0" indent="0" algn="ctr">
              <a:buNone/>
              <a:defRPr sz="1530"/>
            </a:lvl1pPr>
            <a:lvl2pPr marL="291465" indent="0" algn="ctr">
              <a:buNone/>
              <a:defRPr sz="1275"/>
            </a:lvl2pPr>
            <a:lvl3pPr marL="582930" indent="0" algn="ctr">
              <a:buNone/>
              <a:defRPr sz="1148"/>
            </a:lvl3pPr>
            <a:lvl4pPr marL="874395" indent="0" algn="ctr">
              <a:buNone/>
              <a:defRPr sz="1020"/>
            </a:lvl4pPr>
            <a:lvl5pPr marL="1165860" indent="0" algn="ctr">
              <a:buNone/>
              <a:defRPr sz="1020"/>
            </a:lvl5pPr>
            <a:lvl6pPr marL="1457325" indent="0" algn="ctr">
              <a:buNone/>
              <a:defRPr sz="1020"/>
            </a:lvl6pPr>
            <a:lvl7pPr marL="1748790" indent="0" algn="ctr">
              <a:buNone/>
              <a:defRPr sz="1020"/>
            </a:lvl7pPr>
            <a:lvl8pPr marL="2040255" indent="0" algn="ctr">
              <a:buNone/>
              <a:defRPr sz="1020"/>
            </a:lvl8pPr>
            <a:lvl9pPr marL="2331720" indent="0" algn="ctr">
              <a:buNone/>
              <a:defRPr sz="102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52953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1811660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243417"/>
            <a:ext cx="1675924" cy="387455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243417"/>
            <a:ext cx="4930616" cy="387455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0329849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7895098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4" y="1139826"/>
            <a:ext cx="6703695" cy="1901825"/>
          </a:xfrm>
        </p:spPr>
        <p:txBody>
          <a:bodyPr anchor="b"/>
          <a:lstStyle>
            <a:lvl1pPr>
              <a:defRPr sz="382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4" y="3059642"/>
            <a:ext cx="6703695" cy="1000125"/>
          </a:xfrm>
        </p:spPr>
        <p:txBody>
          <a:bodyPr/>
          <a:lstStyle>
            <a:lvl1pPr marL="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1pPr>
            <a:lvl2pPr marL="291465" indent="0">
              <a:buNone/>
              <a:defRPr sz="1275">
                <a:solidFill>
                  <a:schemeClr val="tx1">
                    <a:tint val="75000"/>
                  </a:schemeClr>
                </a:solidFill>
              </a:defRPr>
            </a:lvl2pPr>
            <a:lvl3pPr marL="582930" indent="0">
              <a:buNone/>
              <a:defRPr sz="1148">
                <a:solidFill>
                  <a:schemeClr val="tx1">
                    <a:tint val="75000"/>
                  </a:schemeClr>
                </a:solidFill>
              </a:defRPr>
            </a:lvl3pPr>
            <a:lvl4pPr marL="87439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4pPr>
            <a:lvl5pPr marL="116586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5pPr>
            <a:lvl6pPr marL="145732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6pPr>
            <a:lvl7pPr marL="174879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7pPr>
            <a:lvl8pPr marL="2040255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8pPr>
            <a:lvl9pPr marL="2331720" indent="0">
              <a:buNone/>
              <a:defRPr sz="102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8530572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1217083"/>
            <a:ext cx="330327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1217083"/>
            <a:ext cx="3303270" cy="29008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851991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243417"/>
            <a:ext cx="6703695" cy="88370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5" y="1120775"/>
            <a:ext cx="3288089" cy="549275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5" y="1670050"/>
            <a:ext cx="3288089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1120775"/>
            <a:ext cx="3304282" cy="549275"/>
          </a:xfrm>
        </p:spPr>
        <p:txBody>
          <a:bodyPr anchor="b"/>
          <a:lstStyle>
            <a:lvl1pPr marL="0" indent="0">
              <a:buNone/>
              <a:defRPr sz="1530" b="1"/>
            </a:lvl1pPr>
            <a:lvl2pPr marL="291465" indent="0">
              <a:buNone/>
              <a:defRPr sz="1275" b="1"/>
            </a:lvl2pPr>
            <a:lvl3pPr marL="582930" indent="0">
              <a:buNone/>
              <a:defRPr sz="1148" b="1"/>
            </a:lvl3pPr>
            <a:lvl4pPr marL="874395" indent="0">
              <a:buNone/>
              <a:defRPr sz="1020" b="1"/>
            </a:lvl4pPr>
            <a:lvl5pPr marL="1165860" indent="0">
              <a:buNone/>
              <a:defRPr sz="1020" b="1"/>
            </a:lvl5pPr>
            <a:lvl6pPr marL="1457325" indent="0">
              <a:buNone/>
              <a:defRPr sz="1020" b="1"/>
            </a:lvl6pPr>
            <a:lvl7pPr marL="1748790" indent="0">
              <a:buNone/>
              <a:defRPr sz="1020" b="1"/>
            </a:lvl7pPr>
            <a:lvl8pPr marL="2040255" indent="0">
              <a:buNone/>
              <a:defRPr sz="1020" b="1"/>
            </a:lvl8pPr>
            <a:lvl9pPr marL="2331720" indent="0">
              <a:buNone/>
              <a:defRPr sz="102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1670050"/>
            <a:ext cx="3304282" cy="245639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219437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0025495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3570770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304800"/>
            <a:ext cx="2506801" cy="106680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658284"/>
            <a:ext cx="3934778" cy="3249083"/>
          </a:xfrm>
        </p:spPr>
        <p:txBody>
          <a:bodyPr/>
          <a:lstStyle>
            <a:lvl1pPr>
              <a:defRPr sz="2040"/>
            </a:lvl1pPr>
            <a:lvl2pPr>
              <a:defRPr sz="1785"/>
            </a:lvl2pPr>
            <a:lvl3pPr>
              <a:defRPr sz="1530"/>
            </a:lvl3pPr>
            <a:lvl4pPr>
              <a:defRPr sz="1275"/>
            </a:lvl4pPr>
            <a:lvl5pPr>
              <a:defRPr sz="1275"/>
            </a:lvl5pPr>
            <a:lvl6pPr>
              <a:defRPr sz="1275"/>
            </a:lvl6pPr>
            <a:lvl7pPr>
              <a:defRPr sz="1275"/>
            </a:lvl7pPr>
            <a:lvl8pPr>
              <a:defRPr sz="1275"/>
            </a:lvl8pPr>
            <a:lvl9pPr>
              <a:defRPr sz="1275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1371600"/>
            <a:ext cx="2506801" cy="254105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668135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304800"/>
            <a:ext cx="2506801" cy="1066800"/>
          </a:xfrm>
        </p:spPr>
        <p:txBody>
          <a:bodyPr anchor="b"/>
          <a:lstStyle>
            <a:lvl1pPr>
              <a:defRPr sz="204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658284"/>
            <a:ext cx="3934778" cy="3249083"/>
          </a:xfrm>
        </p:spPr>
        <p:txBody>
          <a:bodyPr anchor="t"/>
          <a:lstStyle>
            <a:lvl1pPr marL="0" indent="0">
              <a:buNone/>
              <a:defRPr sz="2040"/>
            </a:lvl1pPr>
            <a:lvl2pPr marL="291465" indent="0">
              <a:buNone/>
              <a:defRPr sz="1785"/>
            </a:lvl2pPr>
            <a:lvl3pPr marL="582930" indent="0">
              <a:buNone/>
              <a:defRPr sz="1530"/>
            </a:lvl3pPr>
            <a:lvl4pPr marL="874395" indent="0">
              <a:buNone/>
              <a:defRPr sz="1275"/>
            </a:lvl4pPr>
            <a:lvl5pPr marL="1165860" indent="0">
              <a:buNone/>
              <a:defRPr sz="1275"/>
            </a:lvl5pPr>
            <a:lvl6pPr marL="1457325" indent="0">
              <a:buNone/>
              <a:defRPr sz="1275"/>
            </a:lvl6pPr>
            <a:lvl7pPr marL="1748790" indent="0">
              <a:buNone/>
              <a:defRPr sz="1275"/>
            </a:lvl7pPr>
            <a:lvl8pPr marL="2040255" indent="0">
              <a:buNone/>
              <a:defRPr sz="1275"/>
            </a:lvl8pPr>
            <a:lvl9pPr marL="2331720" indent="0">
              <a:buNone/>
              <a:defRPr sz="1275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1371600"/>
            <a:ext cx="2506801" cy="2541059"/>
          </a:xfrm>
        </p:spPr>
        <p:txBody>
          <a:bodyPr/>
          <a:lstStyle>
            <a:lvl1pPr marL="0" indent="0">
              <a:buNone/>
              <a:defRPr sz="1020"/>
            </a:lvl1pPr>
            <a:lvl2pPr marL="291465" indent="0">
              <a:buNone/>
              <a:defRPr sz="893"/>
            </a:lvl2pPr>
            <a:lvl3pPr marL="582930" indent="0">
              <a:buNone/>
              <a:defRPr sz="765"/>
            </a:lvl3pPr>
            <a:lvl4pPr marL="874395" indent="0">
              <a:buNone/>
              <a:defRPr sz="638"/>
            </a:lvl4pPr>
            <a:lvl5pPr marL="1165860" indent="0">
              <a:buNone/>
              <a:defRPr sz="638"/>
            </a:lvl5pPr>
            <a:lvl6pPr marL="1457325" indent="0">
              <a:buNone/>
              <a:defRPr sz="638"/>
            </a:lvl6pPr>
            <a:lvl7pPr marL="1748790" indent="0">
              <a:buNone/>
              <a:defRPr sz="638"/>
            </a:lvl7pPr>
            <a:lvl8pPr marL="2040255" indent="0">
              <a:buNone/>
              <a:defRPr sz="638"/>
            </a:lvl8pPr>
            <a:lvl9pPr marL="2331720" indent="0">
              <a:buNone/>
              <a:defRPr sz="63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0208374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243417"/>
            <a:ext cx="6703695" cy="88370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1217083"/>
            <a:ext cx="6703695" cy="290089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4237567"/>
            <a:ext cx="174879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A39F39-EA0C-48D6-A8F9-A3750804D0BD}" type="datetimeFigureOut">
              <a:rPr lang="en-US" smtClean="0"/>
              <a:t>7/19/23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4237567"/>
            <a:ext cx="2623185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4237567"/>
            <a:ext cx="1748790" cy="2434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6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EC7138-8028-4CE2-B802-D6E21D6CB4B3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062993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582930" rtl="0" eaLnBrk="1" latinLnBrk="0" hangingPunct="1">
        <a:lnSpc>
          <a:spcPct val="90000"/>
        </a:lnSpc>
        <a:spcBef>
          <a:spcPct val="0"/>
        </a:spcBef>
        <a:buNone/>
        <a:defRPr sz="280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45733" indent="-145733" algn="l" defTabSz="582930" rtl="0" eaLnBrk="1" latinLnBrk="0" hangingPunct="1">
        <a:lnSpc>
          <a:spcPct val="90000"/>
        </a:lnSpc>
        <a:spcBef>
          <a:spcPts val="638"/>
        </a:spcBef>
        <a:buFont typeface="Arial" panose="020B0604020202020204" pitchFamily="34" charset="0"/>
        <a:buChar char="•"/>
        <a:defRPr sz="1785" kern="1200">
          <a:solidFill>
            <a:schemeClr val="tx1"/>
          </a:solidFill>
          <a:latin typeface="+mn-lt"/>
          <a:ea typeface="+mn-ea"/>
          <a:cs typeface="+mn-cs"/>
        </a:defRPr>
      </a:lvl1pPr>
      <a:lvl2pPr marL="43719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2866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275" kern="1200">
          <a:solidFill>
            <a:schemeClr val="tx1"/>
          </a:solidFill>
          <a:latin typeface="+mn-lt"/>
          <a:ea typeface="+mn-ea"/>
          <a:cs typeface="+mn-cs"/>
        </a:defRPr>
      </a:lvl3pPr>
      <a:lvl4pPr marL="102012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31159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60305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89452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185988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477453" indent="-145733" algn="l" defTabSz="582930" rtl="0" eaLnBrk="1" latinLnBrk="0" hangingPunct="1">
        <a:lnSpc>
          <a:spcPct val="90000"/>
        </a:lnSpc>
        <a:spcBef>
          <a:spcPts val="319"/>
        </a:spcBef>
        <a:buFont typeface="Arial" panose="020B0604020202020204" pitchFamily="34" charset="0"/>
        <a:buChar char="•"/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1pPr>
      <a:lvl2pPr marL="29146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2pPr>
      <a:lvl3pPr marL="58293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3pPr>
      <a:lvl4pPr marL="87439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4pPr>
      <a:lvl5pPr marL="116586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5pPr>
      <a:lvl6pPr marL="145732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6pPr>
      <a:lvl7pPr marL="174879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7pPr>
      <a:lvl8pPr marL="2040255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algn="l" defTabSz="582930" rtl="0" eaLnBrk="1" latinLnBrk="0" hangingPunct="1">
        <a:defRPr sz="114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TextBox 17"/>
          <p:cNvSpPr txBox="1"/>
          <p:nvPr/>
        </p:nvSpPr>
        <p:spPr>
          <a:xfrm>
            <a:off x="0" y="4142344"/>
            <a:ext cx="5489307" cy="3847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Zhang et al. </a:t>
            </a:r>
            <a:r>
              <a:rPr lang="en-US" sz="1100" i="1" dirty="0">
                <a:latin typeface="Arial" panose="020B0604020202020204" pitchFamily="34" charset="0"/>
                <a:cs typeface="Arial" panose="020B0604020202020204" pitchFamily="34" charset="0"/>
              </a:rPr>
              <a:t>Clin Trans Gastroenterol. 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[Month Year]. [doi]</a:t>
            </a:r>
          </a:p>
          <a:p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All icons above are from </a:t>
            </a:r>
            <a:r>
              <a:rPr lang="en-US" sz="800" dirty="0" err="1">
                <a:latin typeface="Arial" panose="020B0604020202020204" pitchFamily="34" charset="0"/>
                <a:cs typeface="Arial" panose="020B0604020202020204" pitchFamily="34" charset="0"/>
              </a:rPr>
              <a:t>BioRender.com</a:t>
            </a:r>
            <a:r>
              <a:rPr lang="en-US" sz="8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0" y="0"/>
            <a:ext cx="777240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2000" dirty="0">
                <a:latin typeface="Arial" panose="020B0604020202020204" pitchFamily="34" charset="0"/>
                <a:cs typeface="Arial" panose="020B0604020202020204" pitchFamily="34" charset="0"/>
              </a:rPr>
              <a:t>IBD and Pancreatitis Co-Occurrence</a:t>
            </a:r>
          </a:p>
        </p:txBody>
      </p:sp>
      <p:cxnSp>
        <p:nvCxnSpPr>
          <p:cNvPr id="21" name="Straight Connector 20"/>
          <p:cNvCxnSpPr/>
          <p:nvPr/>
        </p:nvCxnSpPr>
        <p:spPr>
          <a:xfrm>
            <a:off x="0" y="4076347"/>
            <a:ext cx="7772400" cy="0"/>
          </a:xfrm>
          <a:prstGeom prst="line">
            <a:avLst/>
          </a:prstGeom>
          <a:ln w="95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8" name="Picture 7">
            <a:extLst>
              <a:ext uri="{FF2B5EF4-FFF2-40B4-BE49-F238E27FC236}">
                <a16:creationId xmlns:a16="http://schemas.microsoft.com/office/drawing/2014/main" id="{D9CF04E7-6655-4E75-B822-92B5B1489C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27650" y="4158048"/>
            <a:ext cx="2103885" cy="350857"/>
          </a:xfrm>
          <a:prstGeom prst="rect">
            <a:avLst/>
          </a:prstGeom>
        </p:spPr>
      </p:pic>
      <p:pic>
        <p:nvPicPr>
          <p:cNvPr id="5" name="Picture 4" descr="A diagram of a patient's diagnosis&#10;&#10;Description automatically generated">
            <a:extLst>
              <a:ext uri="{FF2B5EF4-FFF2-40B4-BE49-F238E27FC236}">
                <a16:creationId xmlns:a16="http://schemas.microsoft.com/office/drawing/2014/main" id="{A546ADFF-3383-7D31-C3EF-73D3B7A88E3D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3044" t="8751" r="14588" b="4853"/>
          <a:stretch/>
        </p:blipFill>
        <p:spPr>
          <a:xfrm>
            <a:off x="1640541" y="414930"/>
            <a:ext cx="4363571" cy="364659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304271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70</TotalTime>
  <Words>28</Words>
  <Application>Microsoft Macintosh PowerPoint</Application>
  <PresentationFormat>Custom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sey Topp</dc:creator>
  <cp:lastModifiedBy>Zachary Michael Sellers</cp:lastModifiedBy>
  <cp:revision>27</cp:revision>
  <dcterms:created xsi:type="dcterms:W3CDTF">2018-03-09T18:47:47Z</dcterms:created>
  <dcterms:modified xsi:type="dcterms:W3CDTF">2023-07-19T19:54:25Z</dcterms:modified>
</cp:coreProperties>
</file>